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4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93" autoAdjust="0"/>
    <p:restoredTop sz="94660"/>
  </p:normalViewPr>
  <p:slideViewPr>
    <p:cSldViewPr snapToGrid="0">
      <p:cViewPr varScale="1">
        <p:scale>
          <a:sx n="72" d="100"/>
          <a:sy n="72" d="100"/>
        </p:scale>
        <p:origin x="57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AD794F4-E24B-4C3A-8DE7-8644BA25239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88C3AD24-262E-48BC-A448-191201D62E2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3BA800E-ADA8-477B-BBFC-0A7F899F07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E49F798-FD2B-4130-ACB2-CCA3DC4B62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C38B6BB-288D-4171-BBDA-DBC99E46E3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883317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429BC7A-9904-4420-A177-0B4824DBF6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4F283BAE-8F74-410B-9C96-6E81A5ADDF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9A8226A-468B-4546-BA59-89A6AE4B9C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31E441E-A9B1-4774-BC4F-BBA3F67BA0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CB4BFE2-0F35-40C6-B2C3-D3D9A0705D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562708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55869236-FDC7-4D96-8AED-B5D7E7581F1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33B1EF50-7D2A-4748-B2F2-FC4D98C1705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3E807BD-4786-4C20-8062-8D30011E4A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E7DCFD0-A0D1-4347-BA44-13D9845723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ACFA070-029E-4735-BE88-D500ECF1CE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475126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4CB7339-993D-4FA5-983D-A25565452F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1B47DAD3-E5E8-4B77-90EE-85559A52A98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9B53BDF-81F5-4F8F-AFDF-5A6B4AA9FF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29D9C04-42B6-4127-9843-4FA0C6F186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77C614B-1C4C-4D6D-A0D8-F1F0E90029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991894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90A6805-5391-4E95-9FE0-B47BF988E1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99AFC12C-9152-4F98-A17C-9BB4D51F80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70902CD-EFDF-4875-A521-8B4E3D0817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5727A39-7441-4A35-9BE0-EA2CC1AFE3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AC4AE2E-7F80-4136-9A9D-8495C05E62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602636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E3131A7-59FC-4143-AFB9-61D62FBD43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531187DF-B6CE-419F-8591-FEA7CB00774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6F17C53F-EEBA-44A4-93C4-45FE81163AB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B7F3DFA8-CF3D-439D-A4ED-78C2E8B4A7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5EE11231-4D9E-4E7E-BCD9-29E577E60F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678DBCEE-06D6-45E6-A437-9A13B38B5A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619379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01A5D13-433A-4C32-9377-E9E9CB814A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596B9F03-B5D8-4411-AF29-0D6DBB765C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A034E265-D882-4DF4-9616-C77492F73F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9956D15D-844B-41D2-9C3C-C28AA875E6C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AE304CC8-348C-4DCE-9D90-43DADF4939F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C86BCF52-C358-43AA-9AF6-40F6D0FA0B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70C02941-E7D3-4F3A-818E-FBF43D25AE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F6C21B59-AC8C-4F42-BA4D-4BBDEDCC5F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183028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E2FCBAB-BD40-4C04-B815-B861D74745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FF55B1DB-BEA0-4D8A-8F3D-EFFDFA5EC1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23D4AA13-C723-47DD-AE5D-73E7DA4F33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72C6CC98-7162-4B63-9D10-73387AAD30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425054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5E06B809-293D-4A41-980C-41F6E8EC74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92783A2A-84E3-4E5D-BC51-18D66AE27D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03C0139A-BD26-4D58-BA2D-4C4FFB2E1A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99911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82F73F1-1F5E-47BE-9822-7E8D75CBF3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BCAA0D1B-CF27-4B03-819E-D30A047BDB0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F27CEC52-2772-4F6A-9ACB-4356295024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C39EC593-D518-4752-8BF9-36A51FC5E9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B1BF9124-C299-487E-87F0-5104F30273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E9D7E7BC-F925-4847-8636-7370A4F227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572932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7A4B86D-21AE-459A-B75D-444345B57A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54E9E3C4-9994-458F-B88B-3D1EB2F14B1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ED3254EA-5F8A-467F-ADC6-16F1533EEE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25A3CAB-D840-486C-9249-BEE944D01A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E007D05F-2401-4BE9-A2C9-29E32A6952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F8EC34F3-15C8-479A-90C6-70CE0D6469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553272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BB40E1D7-86FC-4335-BC71-47C3751E99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2FB86F34-1E8F-4059-B9E8-231681B13B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C3D2838-EAC2-4351-93C6-833B3892586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096AB80-D735-4F56-B486-DFADE9AD984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0C81C39-724B-4D61-BD6A-9A3850C719A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76172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그림 9">
            <a:extLst>
              <a:ext uri="{FF2B5EF4-FFF2-40B4-BE49-F238E27FC236}">
                <a16:creationId xmlns:a16="http://schemas.microsoft.com/office/drawing/2014/main" id="{82D73BC1-168D-4919-950C-1D3B1BA79A1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38265" y="1443396"/>
            <a:ext cx="1247378" cy="1452346"/>
          </a:xfrm>
          <a:prstGeom prst="rect">
            <a:avLst/>
          </a:prstGeom>
        </p:spPr>
      </p:pic>
      <p:pic>
        <p:nvPicPr>
          <p:cNvPr id="11" name="그림 10">
            <a:extLst>
              <a:ext uri="{FF2B5EF4-FFF2-40B4-BE49-F238E27FC236}">
                <a16:creationId xmlns:a16="http://schemas.microsoft.com/office/drawing/2014/main" id="{29A018C5-F178-4293-8944-4D8AB9B1688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27844" y="1585202"/>
            <a:ext cx="1202344" cy="1277491"/>
          </a:xfrm>
          <a:prstGeom prst="rect">
            <a:avLst/>
          </a:prstGeom>
        </p:spPr>
      </p:pic>
      <p:pic>
        <p:nvPicPr>
          <p:cNvPr id="12" name="그림 11">
            <a:extLst>
              <a:ext uri="{FF2B5EF4-FFF2-40B4-BE49-F238E27FC236}">
                <a16:creationId xmlns:a16="http://schemas.microsoft.com/office/drawing/2014/main" id="{9F91EACC-0FC1-4D81-A446-02F3199407D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537616" y="1496495"/>
            <a:ext cx="1085353" cy="1393217"/>
          </a:xfrm>
          <a:prstGeom prst="rect">
            <a:avLst/>
          </a:prstGeom>
        </p:spPr>
      </p:pic>
      <p:pic>
        <p:nvPicPr>
          <p:cNvPr id="16" name="그림 15">
            <a:extLst>
              <a:ext uri="{FF2B5EF4-FFF2-40B4-BE49-F238E27FC236}">
                <a16:creationId xmlns:a16="http://schemas.microsoft.com/office/drawing/2014/main" id="{4082B34E-2A3F-48B7-BF40-61CD205EAE0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871963" y="1697977"/>
            <a:ext cx="360996" cy="984536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6808682D-3C3F-4586-A4B9-810756E74F41}"/>
              </a:ext>
            </a:extLst>
          </p:cNvPr>
          <p:cNvSpPr txBox="1"/>
          <p:nvPr/>
        </p:nvSpPr>
        <p:spPr>
          <a:xfrm>
            <a:off x="10235243" y="1661583"/>
            <a:ext cx="360996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A6E114E-CB2F-4E1D-8356-42CF570B0922}"/>
              </a:ext>
            </a:extLst>
          </p:cNvPr>
          <p:cNvSpPr txBox="1"/>
          <p:nvPr/>
        </p:nvSpPr>
        <p:spPr>
          <a:xfrm>
            <a:off x="9646304" y="1428271"/>
            <a:ext cx="11977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D-mannitol (mM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직선 연결선 19">
            <a:extLst>
              <a:ext uri="{FF2B5EF4-FFF2-40B4-BE49-F238E27FC236}">
                <a16:creationId xmlns:a16="http://schemas.microsoft.com/office/drawing/2014/main" id="{57D324D1-F99F-4248-961D-CA6E697F5DF2}"/>
              </a:ext>
            </a:extLst>
          </p:cNvPr>
          <p:cNvCxnSpPr>
            <a:cxnSpLocks/>
          </p:cNvCxnSpPr>
          <p:nvPr/>
        </p:nvCxnSpPr>
        <p:spPr>
          <a:xfrm>
            <a:off x="10555005" y="1913468"/>
            <a:ext cx="0" cy="64807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73816666-1D91-434A-852B-82B5DBC6FDFC}"/>
              </a:ext>
            </a:extLst>
          </p:cNvPr>
          <p:cNvSpPr txBox="1"/>
          <p:nvPr/>
        </p:nvSpPr>
        <p:spPr>
          <a:xfrm>
            <a:off x="10541697" y="1648953"/>
            <a:ext cx="4764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r>
              <a:rPr lang="en-US" altLang="ko-KR" sz="10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1118</a:t>
            </a:r>
            <a:endParaRPr lang="ko-KR" altLang="en-US" sz="1000" b="1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그림 23">
            <a:extLst>
              <a:ext uri="{FF2B5EF4-FFF2-40B4-BE49-F238E27FC236}">
                <a16:creationId xmlns:a16="http://schemas.microsoft.com/office/drawing/2014/main" id="{5DF8D488-3BB5-4DE8-BBC3-8996E2C560D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368330" y="1806316"/>
            <a:ext cx="360996" cy="984536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09F08333-B1B1-479E-ABB2-C2F8C7FB106A}"/>
              </a:ext>
            </a:extLst>
          </p:cNvPr>
          <p:cNvSpPr txBox="1"/>
          <p:nvPr/>
        </p:nvSpPr>
        <p:spPr>
          <a:xfrm>
            <a:off x="2731610" y="1769922"/>
            <a:ext cx="360996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757A2E3-D3D5-449F-B65F-CDEA2A2EBAB2}"/>
              </a:ext>
            </a:extLst>
          </p:cNvPr>
          <p:cNvSpPr txBox="1"/>
          <p:nvPr/>
        </p:nvSpPr>
        <p:spPr>
          <a:xfrm>
            <a:off x="2142068" y="1519629"/>
            <a:ext cx="13452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Isoproterenol (mM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직선 연결선 26">
            <a:extLst>
              <a:ext uri="{FF2B5EF4-FFF2-40B4-BE49-F238E27FC236}">
                <a16:creationId xmlns:a16="http://schemas.microsoft.com/office/drawing/2014/main" id="{59213D4D-0CCB-448D-AC0E-D35F8562E2D4}"/>
              </a:ext>
            </a:extLst>
          </p:cNvPr>
          <p:cNvCxnSpPr>
            <a:cxnSpLocks/>
          </p:cNvCxnSpPr>
          <p:nvPr/>
        </p:nvCxnSpPr>
        <p:spPr>
          <a:xfrm>
            <a:off x="3029726" y="2025056"/>
            <a:ext cx="0" cy="64807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DB6149BF-ECBA-4479-A034-DACE76FF81AE}"/>
              </a:ext>
            </a:extLst>
          </p:cNvPr>
          <p:cNvSpPr txBox="1"/>
          <p:nvPr/>
        </p:nvSpPr>
        <p:spPr>
          <a:xfrm>
            <a:off x="2966382" y="2247545"/>
            <a:ext cx="9893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md-TRPV1(3)</a:t>
            </a:r>
            <a:endParaRPr lang="ko-KR" alt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8FC623C-0C9A-49B5-B0E9-CF646B36106D}"/>
              </a:ext>
            </a:extLst>
          </p:cNvPr>
          <p:cNvSpPr txBox="1"/>
          <p:nvPr/>
        </p:nvSpPr>
        <p:spPr>
          <a:xfrm>
            <a:off x="3029726" y="1757292"/>
            <a:ext cx="4764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r>
              <a:rPr lang="en-US" altLang="ko-KR" sz="10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1118</a:t>
            </a:r>
            <a:endParaRPr lang="ko-KR" altLang="en-US" sz="1000" b="1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" name="그림 29">
            <a:extLst>
              <a:ext uri="{FF2B5EF4-FFF2-40B4-BE49-F238E27FC236}">
                <a16:creationId xmlns:a16="http://schemas.microsoft.com/office/drawing/2014/main" id="{D2CAB9CD-DBAE-4449-95FF-18A9C78ACBC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146170" y="1945317"/>
            <a:ext cx="360996" cy="984536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584BE7E8-D81C-4B5A-B5D0-041332C583F4}"/>
              </a:ext>
            </a:extLst>
          </p:cNvPr>
          <p:cNvSpPr txBox="1"/>
          <p:nvPr/>
        </p:nvSpPr>
        <p:spPr>
          <a:xfrm>
            <a:off x="6509450" y="1908923"/>
            <a:ext cx="360996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2FA9A432-6EFE-4104-BE77-2EDB02BE3C24}"/>
              </a:ext>
            </a:extLst>
          </p:cNvPr>
          <p:cNvSpPr txBox="1"/>
          <p:nvPr/>
        </p:nvSpPr>
        <p:spPr>
          <a:xfrm>
            <a:off x="5595652" y="1705027"/>
            <a:ext cx="18085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Hydrochlorothiazide (mM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직선 연결선 32">
            <a:extLst>
              <a:ext uri="{FF2B5EF4-FFF2-40B4-BE49-F238E27FC236}">
                <a16:creationId xmlns:a16="http://schemas.microsoft.com/office/drawing/2014/main" id="{B5329DF7-93A7-4D43-9A22-7FAC03397AF0}"/>
              </a:ext>
            </a:extLst>
          </p:cNvPr>
          <p:cNvCxnSpPr>
            <a:cxnSpLocks/>
          </p:cNvCxnSpPr>
          <p:nvPr/>
        </p:nvCxnSpPr>
        <p:spPr>
          <a:xfrm>
            <a:off x="6829212" y="2160808"/>
            <a:ext cx="0" cy="64807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8F12182C-0212-45D8-A0DC-D091F2925184}"/>
              </a:ext>
            </a:extLst>
          </p:cNvPr>
          <p:cNvSpPr txBox="1"/>
          <p:nvPr/>
        </p:nvSpPr>
        <p:spPr>
          <a:xfrm>
            <a:off x="6807567" y="2361734"/>
            <a:ext cx="9893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md-TRPV1(3)</a:t>
            </a:r>
            <a:endParaRPr lang="ko-KR" alt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0ABD82B1-0CF5-4DC4-808E-5267765D14D6}"/>
              </a:ext>
            </a:extLst>
          </p:cNvPr>
          <p:cNvSpPr txBox="1"/>
          <p:nvPr/>
        </p:nvSpPr>
        <p:spPr>
          <a:xfrm>
            <a:off x="6807566" y="1896293"/>
            <a:ext cx="4764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r>
              <a:rPr lang="en-US" altLang="ko-KR" sz="10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1118</a:t>
            </a:r>
            <a:endParaRPr lang="ko-KR" altLang="en-US" sz="1000" b="1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D22B43CC-C5C9-4A6E-AEE4-431CBAB21491}"/>
              </a:ext>
            </a:extLst>
          </p:cNvPr>
          <p:cNvSpPr txBox="1"/>
          <p:nvPr/>
        </p:nvSpPr>
        <p:spPr>
          <a:xfrm>
            <a:off x="10541698" y="2089200"/>
            <a:ext cx="9893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md-TRPV1(3)</a:t>
            </a:r>
            <a:endParaRPr lang="ko-KR" alt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B3741BB1-5BB1-48CA-BA10-C0ED032110BD}"/>
              </a:ext>
            </a:extLst>
          </p:cNvPr>
          <p:cNvSpPr txBox="1"/>
          <p:nvPr/>
        </p:nvSpPr>
        <p:spPr>
          <a:xfrm>
            <a:off x="8767085" y="3036308"/>
            <a:ext cx="10363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Time (days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2CDA2CF2-D31F-42F4-921E-0544F6A3509A}"/>
              </a:ext>
            </a:extLst>
          </p:cNvPr>
          <p:cNvSpPr txBox="1"/>
          <p:nvPr/>
        </p:nvSpPr>
        <p:spPr>
          <a:xfrm>
            <a:off x="1249807" y="3036308"/>
            <a:ext cx="10363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Time (days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CBE8F97A-6F37-4CE2-B106-3D61268ECE3A}"/>
              </a:ext>
            </a:extLst>
          </p:cNvPr>
          <p:cNvSpPr txBox="1"/>
          <p:nvPr/>
        </p:nvSpPr>
        <p:spPr>
          <a:xfrm>
            <a:off x="5013519" y="3036308"/>
            <a:ext cx="10363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Time (days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F33B1632-83D7-43FD-8726-BFFE7FFA8CBC}"/>
              </a:ext>
            </a:extLst>
          </p:cNvPr>
          <p:cNvSpPr txBox="1"/>
          <p:nvPr/>
        </p:nvSpPr>
        <p:spPr>
          <a:xfrm rot="16200000">
            <a:off x="7693634" y="2109563"/>
            <a:ext cx="9962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% Viability 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5B5E0A0D-5F26-4603-A057-51A2A16B8ED4}"/>
              </a:ext>
            </a:extLst>
          </p:cNvPr>
          <p:cNvSpPr txBox="1"/>
          <p:nvPr/>
        </p:nvSpPr>
        <p:spPr>
          <a:xfrm rot="16200000">
            <a:off x="198673" y="2139252"/>
            <a:ext cx="9529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% Viability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328C70A6-DF6C-4A71-9A7A-0F46EE538035}"/>
              </a:ext>
            </a:extLst>
          </p:cNvPr>
          <p:cNvSpPr txBox="1"/>
          <p:nvPr/>
        </p:nvSpPr>
        <p:spPr>
          <a:xfrm rot="16200000">
            <a:off x="3882308" y="2165771"/>
            <a:ext cx="10395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 % Viability 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6DB34943-4CF2-449D-B48D-FD0FEEB0E02D}"/>
              </a:ext>
            </a:extLst>
          </p:cNvPr>
          <p:cNvSpPr txBox="1"/>
          <p:nvPr/>
        </p:nvSpPr>
        <p:spPr>
          <a:xfrm>
            <a:off x="5208496" y="2838750"/>
            <a:ext cx="7489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            2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02B07DDC-0BDA-4B98-98AC-228671747AC8}"/>
              </a:ext>
            </a:extLst>
          </p:cNvPr>
          <p:cNvSpPr txBox="1"/>
          <p:nvPr/>
        </p:nvSpPr>
        <p:spPr>
          <a:xfrm>
            <a:off x="1475637" y="2833695"/>
            <a:ext cx="7489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            2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69EBD168-26B6-42CE-84DE-FCFE3DFAE733}"/>
              </a:ext>
            </a:extLst>
          </p:cNvPr>
          <p:cNvSpPr txBox="1"/>
          <p:nvPr/>
        </p:nvSpPr>
        <p:spPr>
          <a:xfrm>
            <a:off x="8967856" y="2864825"/>
            <a:ext cx="7489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            2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직사각형 63">
            <a:extLst>
              <a:ext uri="{FF2B5EF4-FFF2-40B4-BE49-F238E27FC236}">
                <a16:creationId xmlns:a16="http://schemas.microsoft.com/office/drawing/2014/main" id="{DE565914-2D78-463E-9FDF-E1A678FC0F40}"/>
              </a:ext>
            </a:extLst>
          </p:cNvPr>
          <p:cNvSpPr/>
          <p:nvPr/>
        </p:nvSpPr>
        <p:spPr>
          <a:xfrm>
            <a:off x="9577250" y="1555511"/>
            <a:ext cx="45719" cy="108467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5" name="Text Box 20">
            <a:extLst>
              <a:ext uri="{FF2B5EF4-FFF2-40B4-BE49-F238E27FC236}">
                <a16:creationId xmlns:a16="http://schemas.microsoft.com/office/drawing/2014/main" id="{7AC41DB2-414C-4358-A68B-01CC99F95D8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5711" y="209358"/>
            <a:ext cx="553357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latinLnBrk="0">
              <a:spcBef>
                <a:spcPct val="0"/>
              </a:spcBef>
              <a:buFontTx/>
              <a:buNone/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Fig S9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ABF2AABB-D4A4-4EFC-89E0-438C0195BBD3}"/>
              </a:ext>
            </a:extLst>
          </p:cNvPr>
          <p:cNvSpPr txBox="1"/>
          <p:nvPr/>
        </p:nvSpPr>
        <p:spPr>
          <a:xfrm>
            <a:off x="4547099" y="275387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E30C7E01-E0BC-4BA9-BD5A-249B0E7746C1}"/>
              </a:ext>
            </a:extLst>
          </p:cNvPr>
          <p:cNvSpPr txBox="1"/>
          <p:nvPr/>
        </p:nvSpPr>
        <p:spPr>
          <a:xfrm>
            <a:off x="4476567" y="227551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BA7B775E-F17C-4726-A659-7851E135AD8E}"/>
              </a:ext>
            </a:extLst>
          </p:cNvPr>
          <p:cNvSpPr txBox="1"/>
          <p:nvPr/>
        </p:nvSpPr>
        <p:spPr>
          <a:xfrm>
            <a:off x="4476567" y="178298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5E71CC50-C3CB-44EB-8C98-C81FCB9341FB}"/>
              </a:ext>
            </a:extLst>
          </p:cNvPr>
          <p:cNvSpPr txBox="1"/>
          <p:nvPr/>
        </p:nvSpPr>
        <p:spPr>
          <a:xfrm>
            <a:off x="4476567" y="201650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09EC4869-5A9F-416E-BAB2-0C7F78F0A5DA}"/>
              </a:ext>
            </a:extLst>
          </p:cNvPr>
          <p:cNvSpPr txBox="1"/>
          <p:nvPr/>
        </p:nvSpPr>
        <p:spPr>
          <a:xfrm>
            <a:off x="4406035" y="150638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34E772D1-ECF8-4E94-AEFB-37458B000C30}"/>
              </a:ext>
            </a:extLst>
          </p:cNvPr>
          <p:cNvSpPr txBox="1"/>
          <p:nvPr/>
        </p:nvSpPr>
        <p:spPr>
          <a:xfrm>
            <a:off x="4476567" y="252173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D943E58F-9719-4378-B410-C4B38D630385}"/>
              </a:ext>
            </a:extLst>
          </p:cNvPr>
          <p:cNvSpPr txBox="1"/>
          <p:nvPr/>
        </p:nvSpPr>
        <p:spPr>
          <a:xfrm>
            <a:off x="835130" y="2684012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70F4064D-8BD1-4133-978C-A723B7EB9328}"/>
              </a:ext>
            </a:extLst>
          </p:cNvPr>
          <p:cNvSpPr txBox="1"/>
          <p:nvPr/>
        </p:nvSpPr>
        <p:spPr>
          <a:xfrm>
            <a:off x="764598" y="221874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1CF267FE-5A9B-40D9-B841-8F596E8B9356}"/>
              </a:ext>
            </a:extLst>
          </p:cNvPr>
          <p:cNvSpPr txBox="1"/>
          <p:nvPr/>
        </p:nvSpPr>
        <p:spPr>
          <a:xfrm>
            <a:off x="764598" y="175704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0EB2E66D-FC8E-4CD2-8839-99F9C6F88249}"/>
              </a:ext>
            </a:extLst>
          </p:cNvPr>
          <p:cNvSpPr txBox="1"/>
          <p:nvPr/>
        </p:nvSpPr>
        <p:spPr>
          <a:xfrm>
            <a:off x="764598" y="199842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16ED0FFE-8A91-4AC2-A0EA-B2E452B07412}"/>
              </a:ext>
            </a:extLst>
          </p:cNvPr>
          <p:cNvSpPr txBox="1"/>
          <p:nvPr/>
        </p:nvSpPr>
        <p:spPr>
          <a:xfrm>
            <a:off x="694066" y="1491165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23CE331D-7969-4957-80AD-1EDD90279FAC}"/>
              </a:ext>
            </a:extLst>
          </p:cNvPr>
          <p:cNvSpPr txBox="1"/>
          <p:nvPr/>
        </p:nvSpPr>
        <p:spPr>
          <a:xfrm>
            <a:off x="764598" y="243702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7C52DCEB-4E36-4AB6-86DF-18F10F727C28}"/>
              </a:ext>
            </a:extLst>
          </p:cNvPr>
          <p:cNvSpPr txBox="1"/>
          <p:nvPr/>
        </p:nvSpPr>
        <p:spPr>
          <a:xfrm>
            <a:off x="8351472" y="2708835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58E88176-943D-445D-B390-D8903C9EC843}"/>
              </a:ext>
            </a:extLst>
          </p:cNvPr>
          <p:cNvSpPr txBox="1"/>
          <p:nvPr/>
        </p:nvSpPr>
        <p:spPr>
          <a:xfrm>
            <a:off x="8280940" y="221231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6CE8A01B-FC7F-42D4-92C8-E0CA15B537D1}"/>
              </a:ext>
            </a:extLst>
          </p:cNvPr>
          <p:cNvSpPr txBox="1"/>
          <p:nvPr/>
        </p:nvSpPr>
        <p:spPr>
          <a:xfrm>
            <a:off x="8280940" y="171443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235F0685-88D7-4F4E-828A-B64D3416FDD6}"/>
              </a:ext>
            </a:extLst>
          </p:cNvPr>
          <p:cNvSpPr txBox="1"/>
          <p:nvPr/>
        </p:nvSpPr>
        <p:spPr>
          <a:xfrm>
            <a:off x="8280940" y="195007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676543F0-56BD-4FD0-B275-DB219636E1B1}"/>
              </a:ext>
            </a:extLst>
          </p:cNvPr>
          <p:cNvSpPr txBox="1"/>
          <p:nvPr/>
        </p:nvSpPr>
        <p:spPr>
          <a:xfrm>
            <a:off x="8210408" y="1451757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65B370AA-F7E3-439B-A76F-BAA3571A9635}"/>
              </a:ext>
            </a:extLst>
          </p:cNvPr>
          <p:cNvSpPr txBox="1"/>
          <p:nvPr/>
        </p:nvSpPr>
        <p:spPr>
          <a:xfrm>
            <a:off x="8280940" y="248632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11" name="Text Box 6">
            <a:extLst>
              <a:ext uri="{FF2B5EF4-FFF2-40B4-BE49-F238E27FC236}">
                <a16:creationId xmlns:a16="http://schemas.microsoft.com/office/drawing/2014/main" id="{8A000853-983F-4D65-978A-DBA1D0EA3CA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34312" y="584716"/>
            <a:ext cx="4219425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md-TRPV1(3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 fly viability on capsaicin-containing food</a:t>
            </a:r>
          </a:p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with added non-analgesic drugs</a:t>
            </a:r>
          </a:p>
          <a:p>
            <a:pPr algn="ctr"/>
            <a:endParaRPr lang="en-US" altLang="ko-K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직선 연결선 3">
            <a:extLst>
              <a:ext uri="{FF2B5EF4-FFF2-40B4-BE49-F238E27FC236}">
                <a16:creationId xmlns:a16="http://schemas.microsoft.com/office/drawing/2014/main" id="{D250EAA1-078B-4EC8-B34E-91D53B0136D5}"/>
              </a:ext>
            </a:extLst>
          </p:cNvPr>
          <p:cNvCxnSpPr/>
          <p:nvPr/>
        </p:nvCxnSpPr>
        <p:spPr>
          <a:xfrm>
            <a:off x="944088" y="1199408"/>
            <a:ext cx="932806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795324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37</TotalTime>
  <Words>96</Words>
  <Application>Microsoft Office PowerPoint</Application>
  <PresentationFormat>Widescreen</PresentationFormat>
  <Paragraphs>5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Saranya Siva</cp:lastModifiedBy>
  <cp:revision>149</cp:revision>
  <dcterms:created xsi:type="dcterms:W3CDTF">2022-10-18T02:31:52Z</dcterms:created>
  <dcterms:modified xsi:type="dcterms:W3CDTF">2023-02-08T08:36:38Z</dcterms:modified>
</cp:coreProperties>
</file>